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5D7142-2FD0-4236-9389-EF221569AEE1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892DED-0F1E-4FDB-BCE7-02F01C03F776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70365-CC88-4483-A22B-17855B7840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A90CA-8A3E-40E0-BD48-3DDEA966ED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1264A-190E-4198-9510-EA1877837A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AF76E-560C-4F09-B4AE-8FD6D00344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14115-5138-4E92-944D-14D1061531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14D80-BC3A-4493-ADBC-C457D5A5BE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4BF71F-FF1C-45C2-A796-BC0CF58433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D9287-030F-4FEF-BE16-9A7629BC6F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D92AC-0FD4-4270-8FF4-9845E10E27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E5755-53FE-4797-847E-4AA612241D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ECE40-3603-4A87-B378-A675B077D7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79782-FE64-439C-8D52-77CA5A12D7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26A335-D680-41B1-9AF8-15B93500DAF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684360" y="30600"/>
            <a:ext cx="7704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1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cies adopted for in silico digestion and the corresponding genome siz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684360" y="765000"/>
          <a:ext cx="7921440" cy="5888160"/>
        </p:xfrm>
        <a:graphic>
          <a:graphicData uri="http://schemas.openxmlformats.org/drawingml/2006/table">
            <a:tbl>
              <a:tblPr/>
              <a:tblGrid>
                <a:gridCol w="2216160"/>
                <a:gridCol w="1414440"/>
                <a:gridCol w="1403280"/>
                <a:gridCol w="1731960"/>
                <a:gridCol w="1155600"/>
              </a:tblGrid>
              <a:tr h="436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eci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amil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rde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lass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8eb4e3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caffold length(Mb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rassica rap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ucifer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pparid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3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lycine ma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guminos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os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8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pulus trichocarp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lic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lic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tis vinifer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t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ham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rachypodium distachy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rica papay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ric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iol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yscomitrella pate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unari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unari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ryopsid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8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ucumis sativu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ucurbit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ucurbit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3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8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sa acuminat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s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cit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elumbo nucifera(lotu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ymphae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anuncul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eobroma caca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erculi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lv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6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oenix dactylifer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alm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ncip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5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borella trichopod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ich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mborell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eta vulgar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enopodi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ntrosperm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samum indicu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dali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biflor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3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calyptus grand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yrt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yrtiflor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unus persi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os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os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6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lanum lycopersicu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lanac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biflor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icotyled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8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ryza sativ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yllostachys heterocycl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rghum bicol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8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7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tari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36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ea may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mi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ramina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nocotyledonea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6d9f1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957240" y="836640"/>
          <a:ext cx="7273800" cy="4824360"/>
        </p:xfrm>
        <a:graphic>
          <a:graphicData uri="http://schemas.openxmlformats.org/drawingml/2006/table">
            <a:tbl>
              <a:tblPr/>
              <a:tblGrid>
                <a:gridCol w="1709640"/>
                <a:gridCol w="1658880"/>
                <a:gridCol w="2119320"/>
                <a:gridCol w="1785960"/>
              </a:tblGrid>
              <a:tr h="6033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striction Enzy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cognition Sequenc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cognition Sequence Leng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GC Content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603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bf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TGCAG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033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coR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AT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6033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st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GC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6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015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AvaI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W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6033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sp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G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6030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luC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T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60336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NlaII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51" name="Rectangle 1"/>
          <p:cNvSpPr/>
          <p:nvPr/>
        </p:nvSpPr>
        <p:spPr>
          <a:xfrm>
            <a:off x="250920" y="345240"/>
            <a:ext cx="763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2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striction enzymes included in this stud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矩形 3"/>
          <p:cNvSpPr/>
          <p:nvPr/>
        </p:nvSpPr>
        <p:spPr>
          <a:xfrm>
            <a:off x="971640" y="5732640"/>
            <a:ext cx="662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W represents A or T within the recognition site of AvaII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矩形 2"/>
          <p:cNvSpPr/>
          <p:nvPr/>
        </p:nvSpPr>
        <p:spPr>
          <a:xfrm>
            <a:off x="324000" y="404640"/>
            <a:ext cx="79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3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dependent Sanger sequencing for genotype validation of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i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dRAD-seq genotypin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395280" y="1158840"/>
          <a:ext cx="8064360" cy="4718160"/>
        </p:xfrm>
        <a:graphic>
          <a:graphicData uri="http://schemas.openxmlformats.org/drawingml/2006/table">
            <a:tbl>
              <a:tblPr/>
              <a:tblGrid>
                <a:gridCol w="1571760"/>
                <a:gridCol w="701640"/>
                <a:gridCol w="882720"/>
                <a:gridCol w="701640"/>
                <a:gridCol w="699840"/>
                <a:gridCol w="701640"/>
                <a:gridCol w="702000"/>
                <a:gridCol w="701640"/>
                <a:gridCol w="699840"/>
                <a:gridCol w="701640"/>
              </a:tblGrid>
              <a:tr h="468360"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 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Typ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Genotypin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are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8400" rIns="6840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Offspring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26496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20214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5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676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1182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4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496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4526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6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532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1116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4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676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1260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49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3d69b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/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532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31847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6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496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2836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5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66400"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Marker19119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 rowSpan="2"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-seq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2653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ng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/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400" marR="684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55" name="矩形 6"/>
          <p:cNvSpPr/>
          <p:nvPr/>
        </p:nvSpPr>
        <p:spPr>
          <a:xfrm>
            <a:off x="395280" y="6045120"/>
            <a:ext cx="8424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nconsistent genotypes are marked with red color and the dash line indicates a missing genotype. Sequencing were conducted by Sangon Biotech (Shanghai) Co., Ltd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6" name=""/>
          <p:cNvGraphicFramePr/>
          <p:nvPr/>
        </p:nvGraphicFramePr>
        <p:xfrm>
          <a:off x="378000" y="1125360"/>
          <a:ext cx="8208720" cy="4967640"/>
        </p:xfrm>
        <a:graphic>
          <a:graphicData uri="http://schemas.openxmlformats.org/drawingml/2006/table">
            <a:tbl>
              <a:tblPr/>
              <a:tblGrid>
                <a:gridCol w="863280"/>
                <a:gridCol w="863640"/>
                <a:gridCol w="763560"/>
                <a:gridCol w="887400"/>
                <a:gridCol w="887400"/>
                <a:gridCol w="752760"/>
                <a:gridCol w="1093680"/>
                <a:gridCol w="1093680"/>
                <a:gridCol w="1003320"/>
              </a:tblGrid>
              <a:tr h="1065960"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atego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Techniq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ize selec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Fragment siz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Library 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ep time 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&amp;required experti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Initial outlay cos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ubsequent library 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ost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 per samp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calability to reduce overall 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ost</a:t>
                      </a: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 per samp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eferenc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557640">
                <a:tc rowSpan="5">
                  <a:txBody>
                    <a:bodyPr lIns="62640" rIns="6264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RAD seri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A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ze select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aird et al., 200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5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ze select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g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ry 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terson et al., 20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57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dRA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ze select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ry 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ry 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5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zRA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ze select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ry 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oonen et al., 2013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58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b-RA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–36 b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gh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ang et al., 20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557640">
                <a:tc rowSpan="2">
                  <a:txBody>
                    <a:bodyPr lIns="62640" rIns="6264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GBS seri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B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350 b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to very low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lshire et al., 20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555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-enzyme GBS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350 b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oderate to very 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62640" rIns="62640" tIns="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oland et al., 20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2640" marR="62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57" name="Rectangle 1"/>
          <p:cNvSpPr/>
          <p:nvPr/>
        </p:nvSpPr>
        <p:spPr>
          <a:xfrm>
            <a:off x="0" y="266760"/>
            <a:ext cx="8964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Table S4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omparison of most commonly used RAD and GBS sequencing methodologies and associated cost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矩形 3"/>
          <p:cNvSpPr/>
          <p:nvPr/>
        </p:nvSpPr>
        <p:spPr>
          <a:xfrm>
            <a:off x="415440" y="6192720"/>
            <a:ext cx="535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his table is adapted from Toonen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. (2013) and Poland </a:t>
            </a:r>
            <a:r>
              <a:rPr b="0" i="1" lang="en-US" sz="1400" spc="-1" strike="noStrike">
                <a:solidFill>
                  <a:srgbClr val="000000"/>
                </a:solidFill>
                <a:latin typeface="Calibri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. (2012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矩形 2"/>
          <p:cNvSpPr/>
          <p:nvPr/>
        </p:nvSpPr>
        <p:spPr>
          <a:xfrm>
            <a:off x="73080" y="5732640"/>
            <a:ext cx="8712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1 Library preparation flowchart of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Mi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dRAD Protocol A. Products of all adapter-ligated restriction fragments are as templates of the PCR reaction in Protocol 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内容占位符 3" descr=""/>
          <p:cNvPicPr/>
          <p:nvPr/>
        </p:nvPicPr>
        <p:blipFill>
          <a:blip r:embed="rId1"/>
          <a:stretch/>
        </p:blipFill>
        <p:spPr>
          <a:xfrm>
            <a:off x="2189160" y="165240"/>
            <a:ext cx="4351320" cy="543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图表 3" descr=""/>
          <p:cNvPicPr/>
          <p:nvPr/>
        </p:nvPicPr>
        <p:blipFill>
          <a:blip r:embed="rId1"/>
          <a:stretch/>
        </p:blipFill>
        <p:spPr>
          <a:xfrm>
            <a:off x="-50760" y="3090960"/>
            <a:ext cx="4673520" cy="2844720"/>
          </a:xfrm>
          <a:prstGeom prst="rect">
            <a:avLst/>
          </a:prstGeom>
          <a:ln w="0">
            <a:noFill/>
          </a:ln>
        </p:spPr>
      </p:pic>
      <p:pic>
        <p:nvPicPr>
          <p:cNvPr id="62" name="图表 4" descr=""/>
          <p:cNvPicPr/>
          <p:nvPr/>
        </p:nvPicPr>
        <p:blipFill>
          <a:blip r:embed="rId2"/>
          <a:stretch/>
        </p:blipFill>
        <p:spPr>
          <a:xfrm>
            <a:off x="4521240" y="3090960"/>
            <a:ext cx="4673520" cy="2844720"/>
          </a:xfrm>
          <a:prstGeom prst="rect">
            <a:avLst/>
          </a:prstGeom>
          <a:ln w="0">
            <a:noFill/>
          </a:ln>
        </p:spPr>
      </p:pic>
      <p:sp>
        <p:nvSpPr>
          <p:cNvPr id="63" name="TextBox 1"/>
          <p:cNvSpPr/>
          <p:nvPr/>
        </p:nvSpPr>
        <p:spPr>
          <a:xfrm>
            <a:off x="4572000" y="3238560"/>
            <a:ext cx="36180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8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"/>
          <p:cNvSpPr/>
          <p:nvPr/>
        </p:nvSpPr>
        <p:spPr>
          <a:xfrm>
            <a:off x="395280" y="3143160"/>
            <a:ext cx="361800" cy="19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58000"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矩形 8"/>
          <p:cNvSpPr/>
          <p:nvPr/>
        </p:nvSpPr>
        <p:spPr>
          <a:xfrm>
            <a:off x="179280" y="5743440"/>
            <a:ext cx="8964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2 In silico digestion genome sequences of 23 plant species by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EcoRI+MspI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stI+MspI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.  For each enzyme pair, both total tag number (a, c) and tag number within 400~700bp (b, d) are correlated positively with genome siz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图表 9" descr=""/>
          <p:cNvPicPr/>
          <p:nvPr/>
        </p:nvPicPr>
        <p:blipFill>
          <a:blip r:embed="rId3"/>
          <a:stretch/>
        </p:blipFill>
        <p:spPr>
          <a:xfrm>
            <a:off x="4592520" y="138240"/>
            <a:ext cx="4494240" cy="2549520"/>
          </a:xfrm>
          <a:prstGeom prst="rect">
            <a:avLst/>
          </a:prstGeom>
          <a:ln w="0">
            <a:noFill/>
          </a:ln>
        </p:spPr>
      </p:pic>
      <p:pic>
        <p:nvPicPr>
          <p:cNvPr id="67" name="图表 10" descr=""/>
          <p:cNvPicPr/>
          <p:nvPr/>
        </p:nvPicPr>
        <p:blipFill>
          <a:blip r:embed="rId4"/>
          <a:stretch/>
        </p:blipFill>
        <p:spPr>
          <a:xfrm>
            <a:off x="128520" y="138240"/>
            <a:ext cx="4584600" cy="2624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图片 1" descr="dd"/>
          <p:cNvPicPr/>
          <p:nvPr/>
        </p:nvPicPr>
        <p:blipFill>
          <a:blip r:embed="rId1"/>
          <a:stretch/>
        </p:blipFill>
        <p:spPr>
          <a:xfrm>
            <a:off x="395280" y="797040"/>
            <a:ext cx="2808360" cy="3927240"/>
          </a:xfrm>
          <a:prstGeom prst="rect">
            <a:avLst/>
          </a:prstGeom>
          <a:ln w="0">
            <a:noFill/>
          </a:ln>
        </p:spPr>
      </p:pic>
      <p:sp>
        <p:nvSpPr>
          <p:cNvPr id="69" name="矩形 3"/>
          <p:cNvSpPr/>
          <p:nvPr/>
        </p:nvSpPr>
        <p:spPr>
          <a:xfrm>
            <a:off x="395280" y="5157720"/>
            <a:ext cx="8424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3 Fragments distribution of library A and library B. Fragments distribution of library A (left) and library B (right) screened by the agarose gel electrophoresis is well within the expected range (a). Fragments distribution results of library B was further confirmed by the Agilent 2100 Bioanalyzer (b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"/>
          <p:cNvSpPr/>
          <p:nvPr/>
        </p:nvSpPr>
        <p:spPr>
          <a:xfrm>
            <a:off x="345960" y="773280"/>
            <a:ext cx="50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"/>
          <p:cNvSpPr/>
          <p:nvPr/>
        </p:nvSpPr>
        <p:spPr>
          <a:xfrm>
            <a:off x="3133800" y="790560"/>
            <a:ext cx="36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2" name="Picture 8" descr=""/>
          <p:cNvPicPr/>
          <p:nvPr/>
        </p:nvPicPr>
        <p:blipFill>
          <a:blip r:embed="rId2"/>
          <a:stretch/>
        </p:blipFill>
        <p:spPr>
          <a:xfrm>
            <a:off x="3362400" y="1160640"/>
            <a:ext cx="5290920" cy="3862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矩形 2"/>
          <p:cNvSpPr/>
          <p:nvPr/>
        </p:nvSpPr>
        <p:spPr>
          <a:xfrm>
            <a:off x="324000" y="5229360"/>
            <a:ext cx="8208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. S4 Maximum likelihood phylogenetic reconstruction of 3 bamboo species. One additional RAxML analyses using alternatives data set from Stacks analyses displayed identical topology and minor changes in branch lengths.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D. latiflorus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dividual 1 is sister to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D. latiflorus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dividual 2 and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. rubicunda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s sister to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. vivax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.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2" descr="H:\新加卷4(NTFS)\ddRAD建库\ddRAD_test_data_4th time\hebenke_test\4bamboo\m10M3n5p3\RAxML_bipartitions.result.png"/>
          <p:cNvPicPr/>
          <p:nvPr/>
        </p:nvPicPr>
        <p:blipFill>
          <a:blip r:embed="rId1"/>
          <a:stretch/>
        </p:blipFill>
        <p:spPr>
          <a:xfrm>
            <a:off x="611280" y="189000"/>
            <a:ext cx="7296120" cy="504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2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02T06:36:10Z</dcterms:created>
  <dc:creator>young</dc:creator>
  <dc:description/>
  <dc:language>en-US</dc:language>
  <cp:lastModifiedBy>unknown</cp:lastModifiedBy>
  <dcterms:modified xsi:type="dcterms:W3CDTF">2016-07-20T11:58:43Z</dcterms:modified>
  <cp:revision>54</cp:revision>
  <dc:subject/>
  <dc:title>PowerPoint 演示文稿</dc:title>
</cp:coreProperties>
</file>